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A8D51F-35CD-46F0-834A-74EFCFA4262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298C80-7980-4458-8F84-292C5D376F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CF28F-597B-4D9A-801E-10E95A856B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DE4848-02AA-4C46-B4E1-0329342D21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1EFBC1-B3F4-44B6-90D3-E8E3A327DD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B1BED-AA39-41E9-AD0C-63447C3063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60C831-912A-4063-A9F1-65B4C71CE9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AAE7B-980D-49C1-8E17-04BF1A1177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E325AC-CF1D-4AAB-B8CC-8BE61FB5A0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510F28-262B-4542-A402-A8F42AE5F9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B6419F-BCD9-41BB-A3C0-FEF876474A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E03028-11A5-4882-B782-8408A03109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FCEF101-CC69-4657-BFA7-D4672BC8EB0F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8C937E6-28D8-4DD7-AE32-FD1A1461C9B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"/>
          <p:cNvPicPr/>
          <p:nvPr/>
        </p:nvPicPr>
        <p:blipFill>
          <a:blip r:embed="rId1"/>
          <a:stretch/>
        </p:blipFill>
        <p:spPr>
          <a:xfrm>
            <a:off x="1389240" y="-12600"/>
            <a:ext cx="6243480" cy="675000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2"/>
          <p:cNvSpPr/>
          <p:nvPr/>
        </p:nvSpPr>
        <p:spPr>
          <a:xfrm>
            <a:off x="1440000" y="3852720"/>
            <a:ext cx="955440" cy="9525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3"/>
          <p:cNvSpPr/>
          <p:nvPr/>
        </p:nvSpPr>
        <p:spPr>
          <a:xfrm>
            <a:off x="2344680" y="3157560"/>
            <a:ext cx="741600" cy="7491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4"/>
          <p:cNvSpPr/>
          <p:nvPr/>
        </p:nvSpPr>
        <p:spPr>
          <a:xfrm>
            <a:off x="4451400" y="1689120"/>
            <a:ext cx="120600" cy="1094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5"/>
          <p:cNvSpPr/>
          <p:nvPr/>
        </p:nvSpPr>
        <p:spPr>
          <a:xfrm>
            <a:off x="3086280" y="2303640"/>
            <a:ext cx="804600" cy="8539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6"/>
          <p:cNvSpPr/>
          <p:nvPr/>
        </p:nvSpPr>
        <p:spPr>
          <a:xfrm>
            <a:off x="3890880" y="1798560"/>
            <a:ext cx="560520" cy="5050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7"/>
          <p:cNvSpPr/>
          <p:nvPr/>
        </p:nvSpPr>
        <p:spPr>
          <a:xfrm>
            <a:off x="4543560" y="1579680"/>
            <a:ext cx="122040" cy="1094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9"/>
          <p:cNvSpPr/>
          <p:nvPr/>
        </p:nvSpPr>
        <p:spPr>
          <a:xfrm>
            <a:off x="2402280" y="4270320"/>
            <a:ext cx="875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Heart + muscl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0"/>
          <p:cNvSpPr/>
          <p:nvPr/>
        </p:nvSpPr>
        <p:spPr>
          <a:xfrm>
            <a:off x="3090960" y="3429000"/>
            <a:ext cx="794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Brain + nerv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1"/>
          <p:cNvSpPr/>
          <p:nvPr/>
        </p:nvSpPr>
        <p:spPr>
          <a:xfrm>
            <a:off x="4047840" y="2565360"/>
            <a:ext cx="543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Cell lin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2"/>
          <p:cNvSpPr/>
          <p:nvPr/>
        </p:nvSpPr>
        <p:spPr>
          <a:xfrm>
            <a:off x="4574160" y="1689120"/>
            <a:ext cx="403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Live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3"/>
          <p:cNvSpPr/>
          <p:nvPr/>
        </p:nvSpPr>
        <p:spPr>
          <a:xfrm>
            <a:off x="2352600" y="1866960"/>
            <a:ext cx="1779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Immune system, Endocrine organ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4"/>
          <p:cNvSpPr/>
          <p:nvPr/>
        </p:nvSpPr>
        <p:spPr>
          <a:xfrm>
            <a:off x="3334680" y="1452600"/>
            <a:ext cx="125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Gastrointestinal organ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17" descr=""/>
          <p:cNvPicPr/>
          <p:nvPr/>
        </p:nvPicPr>
        <p:blipFill>
          <a:blip r:embed="rId2"/>
          <a:stretch/>
        </p:blipFill>
        <p:spPr>
          <a:xfrm>
            <a:off x="5948280" y="5048280"/>
            <a:ext cx="444600" cy="463680"/>
          </a:xfrm>
          <a:prstGeom prst="rect">
            <a:avLst/>
          </a:prstGeom>
          <a:ln w="0">
            <a:noFill/>
          </a:ln>
        </p:spPr>
      </p:pic>
      <p:sp>
        <p:nvSpPr>
          <p:cNvPr id="55" name="Rectangle 18"/>
          <p:cNvSpPr/>
          <p:nvPr/>
        </p:nvSpPr>
        <p:spPr>
          <a:xfrm>
            <a:off x="7260840" y="6367320"/>
            <a:ext cx="167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03T13:37:50Z</dcterms:created>
  <dc:creator>Holly Bradley</dc:creator>
  <dc:description/>
  <dc:language>en-US</dc:language>
  <cp:lastModifiedBy>Holly Bradley</cp:lastModifiedBy>
  <dcterms:modified xsi:type="dcterms:W3CDTF">2010-12-16T15:02:39Z</dcterms:modified>
  <cp:revision>2</cp:revision>
  <dc:subject/>
  <dc:title>Slide 1</dc:title>
</cp:coreProperties>
</file>